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C4637-4882-48B1-8FB8-B8223D1C8F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013BF-1574-4CB9-94E7-7D8A009BA4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D5D09-47AD-492A-9B91-60B8ECC496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6B078-F76E-4974-B63E-C97B0674FC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8D188-04DA-44B3-8497-E89630070C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74DFB-1A0F-4093-AA64-71CD0A59EC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B4278-753A-4F86-AE9E-3A634F5F09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FAFEA-7F6B-470D-B927-093D9BCF87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7CF54-2994-4D96-B39E-94E12AEE73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85AEA-1749-4325-BC98-D492F5D82C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9C7F2-8A53-4F14-B64D-3A9C161B25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16D13-DE37-4F34-9478-F4D8282574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03CE9C-A10A-44E7-9A6D-683E0F7C126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981080" y="757080"/>
            <a:ext cx="495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arson correlation  between transcriptome sequencing and microarray differentially expressed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Chart 7" descr=""/>
          <p:cNvPicPr/>
          <p:nvPr/>
        </p:nvPicPr>
        <p:blipFill>
          <a:blip r:embed="rId1"/>
          <a:stretch/>
        </p:blipFill>
        <p:spPr>
          <a:xfrm>
            <a:off x="1292400" y="1292400"/>
            <a:ext cx="6321240" cy="3773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3"/>
          <p:cNvSpPr/>
          <p:nvPr/>
        </p:nvSpPr>
        <p:spPr>
          <a:xfrm>
            <a:off x="311760" y="304920"/>
            <a:ext cx="130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Additional file 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20:33:34Z</dcterms:created>
  <dc:creator>Alok</dc:creator>
  <dc:description/>
  <dc:language>en-US</dc:language>
  <cp:lastModifiedBy>neha</cp:lastModifiedBy>
  <dcterms:modified xsi:type="dcterms:W3CDTF">2012-01-25T13:11:34Z</dcterms:modified>
  <cp:revision>12</cp:revision>
  <dc:subject/>
  <dc:title>Slide 1</dc:title>
</cp:coreProperties>
</file>